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  <p:sldId id="257" r:id="rId3"/>
  </p:sldIdLst>
  <p:sldSz cx="17610138" cy="172799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6" d="100"/>
          <a:sy n="46" d="100"/>
        </p:scale>
        <p:origin x="22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20761" y="2827991"/>
            <a:ext cx="14968617" cy="6015978"/>
          </a:xfrm>
        </p:spPr>
        <p:txBody>
          <a:bodyPr anchor="b"/>
          <a:lstStyle>
            <a:lvl1pPr algn="ctr">
              <a:defRPr sz="1155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9075969"/>
            <a:ext cx="13207604" cy="4171984"/>
          </a:xfrm>
        </p:spPr>
        <p:txBody>
          <a:bodyPr/>
          <a:lstStyle>
            <a:lvl1pPr marL="0" indent="0" algn="ctr">
              <a:buNone/>
              <a:defRPr sz="4622"/>
            </a:lvl1pPr>
            <a:lvl2pPr marL="880521" indent="0" algn="ctr">
              <a:buNone/>
              <a:defRPr sz="3852"/>
            </a:lvl2pPr>
            <a:lvl3pPr marL="1761043" indent="0" algn="ctr">
              <a:buNone/>
              <a:defRPr sz="3467"/>
            </a:lvl3pPr>
            <a:lvl4pPr marL="2641564" indent="0" algn="ctr">
              <a:buNone/>
              <a:defRPr sz="3081"/>
            </a:lvl4pPr>
            <a:lvl5pPr marL="3522086" indent="0" algn="ctr">
              <a:buNone/>
              <a:defRPr sz="3081"/>
            </a:lvl5pPr>
            <a:lvl6pPr marL="4402607" indent="0" algn="ctr">
              <a:buNone/>
              <a:defRPr sz="3081"/>
            </a:lvl6pPr>
            <a:lvl7pPr marL="5283129" indent="0" algn="ctr">
              <a:buNone/>
              <a:defRPr sz="3081"/>
            </a:lvl7pPr>
            <a:lvl8pPr marL="6163650" indent="0" algn="ctr">
              <a:buNone/>
              <a:defRPr sz="3081"/>
            </a:lvl8pPr>
            <a:lvl9pPr marL="7044172" indent="0" algn="ctr">
              <a:buNone/>
              <a:defRPr sz="3081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389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596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6" y="919997"/>
            <a:ext cx="3797186" cy="14643949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8" y="919997"/>
            <a:ext cx="11171431" cy="14643949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724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8918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6" y="4307990"/>
            <a:ext cx="15188744" cy="7187973"/>
          </a:xfrm>
        </p:spPr>
        <p:txBody>
          <a:bodyPr anchor="b"/>
          <a:lstStyle>
            <a:lvl1pPr>
              <a:defRPr sz="1155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6" y="11563964"/>
            <a:ext cx="15188744" cy="3779985"/>
          </a:xfrm>
        </p:spPr>
        <p:txBody>
          <a:bodyPr/>
          <a:lstStyle>
            <a:lvl1pPr marL="0" indent="0">
              <a:buNone/>
              <a:defRPr sz="4622">
                <a:solidFill>
                  <a:schemeClr val="tx1"/>
                </a:solidFill>
              </a:defRPr>
            </a:lvl1pPr>
            <a:lvl2pPr marL="880521" indent="0">
              <a:buNone/>
              <a:defRPr sz="3852">
                <a:solidFill>
                  <a:schemeClr val="tx1">
                    <a:tint val="75000"/>
                  </a:schemeClr>
                </a:solidFill>
              </a:defRPr>
            </a:lvl2pPr>
            <a:lvl3pPr marL="1761043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3pPr>
            <a:lvl4pPr marL="2641564" indent="0">
              <a:buNone/>
              <a:defRPr sz="3081">
                <a:solidFill>
                  <a:schemeClr val="tx1">
                    <a:tint val="75000"/>
                  </a:schemeClr>
                </a:solidFill>
              </a:defRPr>
            </a:lvl4pPr>
            <a:lvl5pPr marL="3522086" indent="0">
              <a:buNone/>
              <a:defRPr sz="3081">
                <a:solidFill>
                  <a:schemeClr val="tx1">
                    <a:tint val="75000"/>
                  </a:schemeClr>
                </a:solidFill>
              </a:defRPr>
            </a:lvl5pPr>
            <a:lvl6pPr marL="4402607" indent="0">
              <a:buNone/>
              <a:defRPr sz="3081">
                <a:solidFill>
                  <a:schemeClr val="tx1">
                    <a:tint val="75000"/>
                  </a:schemeClr>
                </a:solidFill>
              </a:defRPr>
            </a:lvl6pPr>
            <a:lvl7pPr marL="5283129" indent="0">
              <a:buNone/>
              <a:defRPr sz="3081">
                <a:solidFill>
                  <a:schemeClr val="tx1">
                    <a:tint val="75000"/>
                  </a:schemeClr>
                </a:solidFill>
              </a:defRPr>
            </a:lvl7pPr>
            <a:lvl8pPr marL="6163650" indent="0">
              <a:buNone/>
              <a:defRPr sz="3081">
                <a:solidFill>
                  <a:schemeClr val="tx1">
                    <a:tint val="75000"/>
                  </a:schemeClr>
                </a:solidFill>
              </a:defRPr>
            </a:lvl8pPr>
            <a:lvl9pPr marL="7044172" indent="0">
              <a:buNone/>
              <a:defRPr sz="308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6431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4599983"/>
            <a:ext cx="7484309" cy="1096396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4599983"/>
            <a:ext cx="7484309" cy="1096396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1395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920001"/>
            <a:ext cx="15188744" cy="333998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2" y="4235986"/>
            <a:ext cx="7449913" cy="2075991"/>
          </a:xfrm>
        </p:spPr>
        <p:txBody>
          <a:bodyPr anchor="b"/>
          <a:lstStyle>
            <a:lvl1pPr marL="0" indent="0">
              <a:buNone/>
              <a:defRPr sz="4622" b="1"/>
            </a:lvl1pPr>
            <a:lvl2pPr marL="880521" indent="0">
              <a:buNone/>
              <a:defRPr sz="3852" b="1"/>
            </a:lvl2pPr>
            <a:lvl3pPr marL="1761043" indent="0">
              <a:buNone/>
              <a:defRPr sz="3467" b="1"/>
            </a:lvl3pPr>
            <a:lvl4pPr marL="2641564" indent="0">
              <a:buNone/>
              <a:defRPr sz="3081" b="1"/>
            </a:lvl4pPr>
            <a:lvl5pPr marL="3522086" indent="0">
              <a:buNone/>
              <a:defRPr sz="3081" b="1"/>
            </a:lvl5pPr>
            <a:lvl6pPr marL="4402607" indent="0">
              <a:buNone/>
              <a:defRPr sz="3081" b="1"/>
            </a:lvl6pPr>
            <a:lvl7pPr marL="5283129" indent="0">
              <a:buNone/>
              <a:defRPr sz="3081" b="1"/>
            </a:lvl7pPr>
            <a:lvl8pPr marL="6163650" indent="0">
              <a:buNone/>
              <a:defRPr sz="3081" b="1"/>
            </a:lvl8pPr>
            <a:lvl9pPr marL="7044172" indent="0">
              <a:buNone/>
              <a:defRPr sz="3081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2" y="6311977"/>
            <a:ext cx="7449913" cy="928396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4" y="4235986"/>
            <a:ext cx="7486602" cy="2075991"/>
          </a:xfrm>
        </p:spPr>
        <p:txBody>
          <a:bodyPr anchor="b"/>
          <a:lstStyle>
            <a:lvl1pPr marL="0" indent="0">
              <a:buNone/>
              <a:defRPr sz="4622" b="1"/>
            </a:lvl1pPr>
            <a:lvl2pPr marL="880521" indent="0">
              <a:buNone/>
              <a:defRPr sz="3852" b="1"/>
            </a:lvl2pPr>
            <a:lvl3pPr marL="1761043" indent="0">
              <a:buNone/>
              <a:defRPr sz="3467" b="1"/>
            </a:lvl3pPr>
            <a:lvl4pPr marL="2641564" indent="0">
              <a:buNone/>
              <a:defRPr sz="3081" b="1"/>
            </a:lvl4pPr>
            <a:lvl5pPr marL="3522086" indent="0">
              <a:buNone/>
              <a:defRPr sz="3081" b="1"/>
            </a:lvl5pPr>
            <a:lvl6pPr marL="4402607" indent="0">
              <a:buNone/>
              <a:defRPr sz="3081" b="1"/>
            </a:lvl6pPr>
            <a:lvl7pPr marL="5283129" indent="0">
              <a:buNone/>
              <a:defRPr sz="3081" b="1"/>
            </a:lvl7pPr>
            <a:lvl8pPr marL="6163650" indent="0">
              <a:buNone/>
              <a:defRPr sz="3081" b="1"/>
            </a:lvl8pPr>
            <a:lvl9pPr marL="7044172" indent="0">
              <a:buNone/>
              <a:defRPr sz="3081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4" y="6311977"/>
            <a:ext cx="7486602" cy="928396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0619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4502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784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1151996"/>
            <a:ext cx="5679728" cy="4031986"/>
          </a:xfrm>
        </p:spPr>
        <p:txBody>
          <a:bodyPr anchor="b"/>
          <a:lstStyle>
            <a:lvl1pPr>
              <a:defRPr sz="616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2487995"/>
            <a:ext cx="8915132" cy="12279956"/>
          </a:xfrm>
        </p:spPr>
        <p:txBody>
          <a:bodyPr/>
          <a:lstStyle>
            <a:lvl1pPr>
              <a:defRPr sz="6163"/>
            </a:lvl1pPr>
            <a:lvl2pPr>
              <a:defRPr sz="5393"/>
            </a:lvl2pPr>
            <a:lvl3pPr>
              <a:defRPr sz="4622"/>
            </a:lvl3pPr>
            <a:lvl4pPr>
              <a:defRPr sz="3852"/>
            </a:lvl4pPr>
            <a:lvl5pPr>
              <a:defRPr sz="3852"/>
            </a:lvl5pPr>
            <a:lvl6pPr>
              <a:defRPr sz="3852"/>
            </a:lvl6pPr>
            <a:lvl7pPr>
              <a:defRPr sz="3852"/>
            </a:lvl7pPr>
            <a:lvl8pPr>
              <a:defRPr sz="3852"/>
            </a:lvl8pPr>
            <a:lvl9pPr>
              <a:defRPr sz="3852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1" y="5183981"/>
            <a:ext cx="5679728" cy="9603967"/>
          </a:xfrm>
        </p:spPr>
        <p:txBody>
          <a:bodyPr/>
          <a:lstStyle>
            <a:lvl1pPr marL="0" indent="0">
              <a:buNone/>
              <a:defRPr sz="3081"/>
            </a:lvl1pPr>
            <a:lvl2pPr marL="880521" indent="0">
              <a:buNone/>
              <a:defRPr sz="2696"/>
            </a:lvl2pPr>
            <a:lvl3pPr marL="1761043" indent="0">
              <a:buNone/>
              <a:defRPr sz="2311"/>
            </a:lvl3pPr>
            <a:lvl4pPr marL="2641564" indent="0">
              <a:buNone/>
              <a:defRPr sz="1926"/>
            </a:lvl4pPr>
            <a:lvl5pPr marL="3522086" indent="0">
              <a:buNone/>
              <a:defRPr sz="1926"/>
            </a:lvl5pPr>
            <a:lvl6pPr marL="4402607" indent="0">
              <a:buNone/>
              <a:defRPr sz="1926"/>
            </a:lvl6pPr>
            <a:lvl7pPr marL="5283129" indent="0">
              <a:buNone/>
              <a:defRPr sz="1926"/>
            </a:lvl7pPr>
            <a:lvl8pPr marL="6163650" indent="0">
              <a:buNone/>
              <a:defRPr sz="1926"/>
            </a:lvl8pPr>
            <a:lvl9pPr marL="7044172" indent="0">
              <a:buNone/>
              <a:defRPr sz="1926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0177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1151996"/>
            <a:ext cx="5679728" cy="4031986"/>
          </a:xfrm>
        </p:spPr>
        <p:txBody>
          <a:bodyPr anchor="b"/>
          <a:lstStyle>
            <a:lvl1pPr>
              <a:defRPr sz="616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2487995"/>
            <a:ext cx="8915132" cy="12279956"/>
          </a:xfrm>
        </p:spPr>
        <p:txBody>
          <a:bodyPr anchor="t"/>
          <a:lstStyle>
            <a:lvl1pPr marL="0" indent="0">
              <a:buNone/>
              <a:defRPr sz="6163"/>
            </a:lvl1pPr>
            <a:lvl2pPr marL="880521" indent="0">
              <a:buNone/>
              <a:defRPr sz="5393"/>
            </a:lvl2pPr>
            <a:lvl3pPr marL="1761043" indent="0">
              <a:buNone/>
              <a:defRPr sz="4622"/>
            </a:lvl3pPr>
            <a:lvl4pPr marL="2641564" indent="0">
              <a:buNone/>
              <a:defRPr sz="3852"/>
            </a:lvl4pPr>
            <a:lvl5pPr marL="3522086" indent="0">
              <a:buNone/>
              <a:defRPr sz="3852"/>
            </a:lvl5pPr>
            <a:lvl6pPr marL="4402607" indent="0">
              <a:buNone/>
              <a:defRPr sz="3852"/>
            </a:lvl6pPr>
            <a:lvl7pPr marL="5283129" indent="0">
              <a:buNone/>
              <a:defRPr sz="3852"/>
            </a:lvl7pPr>
            <a:lvl8pPr marL="6163650" indent="0">
              <a:buNone/>
              <a:defRPr sz="3852"/>
            </a:lvl8pPr>
            <a:lvl9pPr marL="7044172" indent="0">
              <a:buNone/>
              <a:defRPr sz="3852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1" y="5183981"/>
            <a:ext cx="5679728" cy="9603967"/>
          </a:xfrm>
        </p:spPr>
        <p:txBody>
          <a:bodyPr/>
          <a:lstStyle>
            <a:lvl1pPr marL="0" indent="0">
              <a:buNone/>
              <a:defRPr sz="3081"/>
            </a:lvl1pPr>
            <a:lvl2pPr marL="880521" indent="0">
              <a:buNone/>
              <a:defRPr sz="2696"/>
            </a:lvl2pPr>
            <a:lvl3pPr marL="1761043" indent="0">
              <a:buNone/>
              <a:defRPr sz="2311"/>
            </a:lvl3pPr>
            <a:lvl4pPr marL="2641564" indent="0">
              <a:buNone/>
              <a:defRPr sz="1926"/>
            </a:lvl4pPr>
            <a:lvl5pPr marL="3522086" indent="0">
              <a:buNone/>
              <a:defRPr sz="1926"/>
            </a:lvl5pPr>
            <a:lvl6pPr marL="4402607" indent="0">
              <a:buNone/>
              <a:defRPr sz="1926"/>
            </a:lvl6pPr>
            <a:lvl7pPr marL="5283129" indent="0">
              <a:buNone/>
              <a:defRPr sz="1926"/>
            </a:lvl7pPr>
            <a:lvl8pPr marL="6163650" indent="0">
              <a:buNone/>
              <a:defRPr sz="1926"/>
            </a:lvl8pPr>
            <a:lvl9pPr marL="7044172" indent="0">
              <a:buNone/>
              <a:defRPr sz="1926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6851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920001"/>
            <a:ext cx="15188744" cy="33399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4599983"/>
            <a:ext cx="15188744" cy="10963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16015946"/>
            <a:ext cx="3962281" cy="9199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4D400D-BD8A-414A-8869-F66F7CAF165F}" type="datetimeFigureOut">
              <a:rPr lang="de-DE" smtClean="0"/>
              <a:t>28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16015946"/>
            <a:ext cx="5943422" cy="9199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16015946"/>
            <a:ext cx="3962281" cy="9199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67C3DF-56E2-476C-BD42-308098D635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7631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761043" rtl="0" eaLnBrk="1" latinLnBrk="0" hangingPunct="1">
        <a:lnSpc>
          <a:spcPct val="90000"/>
        </a:lnSpc>
        <a:spcBef>
          <a:spcPct val="0"/>
        </a:spcBef>
        <a:buNone/>
        <a:defRPr sz="84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40261" indent="-440261" algn="l" defTabSz="1761043" rtl="0" eaLnBrk="1" latinLnBrk="0" hangingPunct="1">
        <a:lnSpc>
          <a:spcPct val="90000"/>
        </a:lnSpc>
        <a:spcBef>
          <a:spcPts val="1926"/>
        </a:spcBef>
        <a:buFont typeface="Arial" panose="020B0604020202020204" pitchFamily="34" charset="0"/>
        <a:buChar char="•"/>
        <a:defRPr sz="5393" kern="1200">
          <a:solidFill>
            <a:schemeClr val="tx1"/>
          </a:solidFill>
          <a:latin typeface="+mn-lt"/>
          <a:ea typeface="+mn-ea"/>
          <a:cs typeface="+mn-cs"/>
        </a:defRPr>
      </a:lvl1pPr>
      <a:lvl2pPr marL="1320782" indent="-440261" algn="l" defTabSz="176104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2pPr>
      <a:lvl3pPr marL="2201304" indent="-440261" algn="l" defTabSz="176104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3852" kern="1200">
          <a:solidFill>
            <a:schemeClr val="tx1"/>
          </a:solidFill>
          <a:latin typeface="+mn-lt"/>
          <a:ea typeface="+mn-ea"/>
          <a:cs typeface="+mn-cs"/>
        </a:defRPr>
      </a:lvl3pPr>
      <a:lvl4pPr marL="3081825" indent="-440261" algn="l" defTabSz="176104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4pPr>
      <a:lvl5pPr marL="3962347" indent="-440261" algn="l" defTabSz="176104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5pPr>
      <a:lvl6pPr marL="4842868" indent="-440261" algn="l" defTabSz="176104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6pPr>
      <a:lvl7pPr marL="5723390" indent="-440261" algn="l" defTabSz="176104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7pPr>
      <a:lvl8pPr marL="6603911" indent="-440261" algn="l" defTabSz="176104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8pPr>
      <a:lvl9pPr marL="7484433" indent="-440261" algn="l" defTabSz="176104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1pPr>
      <a:lvl2pPr marL="880521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761043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641564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4pPr>
      <a:lvl5pPr marL="3522086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5pPr>
      <a:lvl6pPr marL="4402607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6pPr>
      <a:lvl7pPr marL="5283129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7pPr>
      <a:lvl8pPr marL="6163650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8pPr>
      <a:lvl9pPr marL="7044172" algn="l" defTabSz="1761043" rtl="0" eaLnBrk="1" latinLnBrk="0" hangingPunct="1">
        <a:defRPr sz="34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feld 64"/>
          <p:cNvSpPr txBox="1"/>
          <p:nvPr/>
        </p:nvSpPr>
        <p:spPr>
          <a:xfrm>
            <a:off x="3389937" y="547218"/>
            <a:ext cx="116236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 smtClean="0"/>
              <a:t>Time Gate</a:t>
            </a:r>
            <a:endParaRPr lang="de-DE" b="1" dirty="0"/>
          </a:p>
        </p:txBody>
      </p:sp>
      <p:sp>
        <p:nvSpPr>
          <p:cNvPr id="66" name="Textfeld 65"/>
          <p:cNvSpPr txBox="1"/>
          <p:nvPr/>
        </p:nvSpPr>
        <p:spPr>
          <a:xfrm>
            <a:off x="8032627" y="559332"/>
            <a:ext cx="124745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 smtClean="0"/>
              <a:t>Single Cells</a:t>
            </a:r>
            <a:endParaRPr lang="de-DE" b="1" dirty="0"/>
          </a:p>
        </p:txBody>
      </p:sp>
      <p:sp>
        <p:nvSpPr>
          <p:cNvPr id="67" name="Textfeld 66"/>
          <p:cNvSpPr txBox="1"/>
          <p:nvPr/>
        </p:nvSpPr>
        <p:spPr>
          <a:xfrm>
            <a:off x="12605045" y="559332"/>
            <a:ext cx="143039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 err="1" smtClean="0"/>
              <a:t>Lymphocytes</a:t>
            </a:r>
            <a:endParaRPr lang="de-DE" b="1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8817" y="952547"/>
            <a:ext cx="2952751" cy="2867024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75776" y="948035"/>
            <a:ext cx="3009901" cy="286702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559885" y="948038"/>
            <a:ext cx="3009901" cy="2867024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572210" y="4445717"/>
            <a:ext cx="2981326" cy="2867024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04353" y="4445713"/>
            <a:ext cx="2981326" cy="291465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20243" y="4445713"/>
            <a:ext cx="2981326" cy="2914650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59593" y="7498229"/>
            <a:ext cx="2981326" cy="291465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318667" y="7498227"/>
            <a:ext cx="2981326" cy="2914650"/>
          </a:xfrm>
          <a:prstGeom prst="rect">
            <a:avLst/>
          </a:prstGeom>
        </p:spPr>
      </p:pic>
      <p:sp>
        <p:nvSpPr>
          <p:cNvPr id="17" name="Pfeil nach rechts 16"/>
          <p:cNvSpPr/>
          <p:nvPr/>
        </p:nvSpPr>
        <p:spPr>
          <a:xfrm>
            <a:off x="5419046" y="2083768"/>
            <a:ext cx="1239252" cy="29777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Pfeil nach rechts 17"/>
          <p:cNvSpPr/>
          <p:nvPr/>
        </p:nvSpPr>
        <p:spPr>
          <a:xfrm>
            <a:off x="10103155" y="2083768"/>
            <a:ext cx="1239252" cy="29777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Pfeil nach rechts 18"/>
          <p:cNvSpPr/>
          <p:nvPr/>
        </p:nvSpPr>
        <p:spPr>
          <a:xfrm rot="10800000">
            <a:off x="10103153" y="5574684"/>
            <a:ext cx="1239252" cy="29777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" name="Pfeil nach rechts 19"/>
          <p:cNvSpPr/>
          <p:nvPr/>
        </p:nvSpPr>
        <p:spPr>
          <a:xfrm rot="10800000">
            <a:off x="5419044" y="5605264"/>
            <a:ext cx="1239252" cy="29777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Pfeil nach rechts 22"/>
          <p:cNvSpPr/>
          <p:nvPr/>
        </p:nvSpPr>
        <p:spPr>
          <a:xfrm rot="5400000">
            <a:off x="11898594" y="3850928"/>
            <a:ext cx="626616" cy="29777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Nach oben gebogener Pfeil 24"/>
          <p:cNvSpPr/>
          <p:nvPr/>
        </p:nvSpPr>
        <p:spPr>
          <a:xfrm rot="5400000" flipV="1">
            <a:off x="7976463" y="7561571"/>
            <a:ext cx="837103" cy="608346"/>
          </a:xfrm>
          <a:prstGeom prst="bent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6" name="Nach oben gebogener Pfeil 25"/>
          <p:cNvSpPr/>
          <p:nvPr/>
        </p:nvSpPr>
        <p:spPr>
          <a:xfrm rot="16200000" flipH="1" flipV="1">
            <a:off x="8432824" y="7561569"/>
            <a:ext cx="837103" cy="608346"/>
          </a:xfrm>
          <a:prstGeom prst="bent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Rechteck 26"/>
          <p:cNvSpPr/>
          <p:nvPr/>
        </p:nvSpPr>
        <p:spPr>
          <a:xfrm>
            <a:off x="2749512" y="936004"/>
            <a:ext cx="2447999" cy="24471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28" name="Rechteck 27"/>
          <p:cNvSpPr/>
          <p:nvPr/>
        </p:nvSpPr>
        <p:spPr>
          <a:xfrm>
            <a:off x="7435168" y="948034"/>
            <a:ext cx="2447999" cy="24471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Rechteck 28"/>
          <p:cNvSpPr/>
          <p:nvPr/>
        </p:nvSpPr>
        <p:spPr>
          <a:xfrm>
            <a:off x="12124817" y="948034"/>
            <a:ext cx="2447999" cy="24471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Rechteck 29"/>
          <p:cNvSpPr/>
          <p:nvPr/>
        </p:nvSpPr>
        <p:spPr>
          <a:xfrm>
            <a:off x="2756649" y="4445716"/>
            <a:ext cx="2447999" cy="24471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Rechteck 30"/>
          <p:cNvSpPr/>
          <p:nvPr/>
        </p:nvSpPr>
        <p:spPr>
          <a:xfrm>
            <a:off x="7435168" y="4445716"/>
            <a:ext cx="2447999" cy="24471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/>
          <p:cNvSpPr/>
          <p:nvPr/>
        </p:nvSpPr>
        <p:spPr>
          <a:xfrm>
            <a:off x="12106110" y="4445716"/>
            <a:ext cx="2447999" cy="24471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" name="Rechteck 32"/>
          <p:cNvSpPr/>
          <p:nvPr/>
        </p:nvSpPr>
        <p:spPr>
          <a:xfrm>
            <a:off x="5093538" y="7485530"/>
            <a:ext cx="2447999" cy="24471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" name="Rechteck 33"/>
          <p:cNvSpPr/>
          <p:nvPr/>
        </p:nvSpPr>
        <p:spPr>
          <a:xfrm>
            <a:off x="9847073" y="7485530"/>
            <a:ext cx="2447999" cy="24471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5" name="Rechteck 34"/>
          <p:cNvSpPr/>
          <p:nvPr/>
        </p:nvSpPr>
        <p:spPr>
          <a:xfrm>
            <a:off x="2986132" y="1295319"/>
            <a:ext cx="2196001" cy="201600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7" name="Ellipse 36"/>
          <p:cNvSpPr/>
          <p:nvPr/>
        </p:nvSpPr>
        <p:spPr>
          <a:xfrm rot="2967196">
            <a:off x="12951336" y="2553202"/>
            <a:ext cx="399546" cy="781599"/>
          </a:xfrm>
          <a:prstGeom prst="ellipse">
            <a:avLst/>
          </a:prstGeom>
          <a:noFill/>
          <a:ln w="381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" name="Rechteck 37"/>
          <p:cNvSpPr/>
          <p:nvPr/>
        </p:nvSpPr>
        <p:spPr>
          <a:xfrm>
            <a:off x="3071672" y="4823769"/>
            <a:ext cx="411766" cy="120702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40" name="Gerader Verbinder 39"/>
          <p:cNvCxnSpPr/>
          <p:nvPr/>
        </p:nvCxnSpPr>
        <p:spPr>
          <a:xfrm flipV="1">
            <a:off x="3071672" y="5211975"/>
            <a:ext cx="41176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Rechteck 40"/>
          <p:cNvSpPr/>
          <p:nvPr/>
        </p:nvSpPr>
        <p:spPr>
          <a:xfrm>
            <a:off x="7763852" y="4811069"/>
            <a:ext cx="411766" cy="120702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2" name="Rechteck 41"/>
          <p:cNvSpPr/>
          <p:nvPr/>
        </p:nvSpPr>
        <p:spPr>
          <a:xfrm>
            <a:off x="12360791" y="5994026"/>
            <a:ext cx="1734501" cy="89886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3" name="Rechteck 42"/>
          <p:cNvSpPr/>
          <p:nvPr/>
        </p:nvSpPr>
        <p:spPr>
          <a:xfrm>
            <a:off x="5844372" y="7796659"/>
            <a:ext cx="1224475" cy="135139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4" name="Rechteck 43"/>
          <p:cNvSpPr/>
          <p:nvPr/>
        </p:nvSpPr>
        <p:spPr>
          <a:xfrm>
            <a:off x="10824743" y="7817887"/>
            <a:ext cx="1357524" cy="131838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Freihandform 45"/>
          <p:cNvSpPr/>
          <p:nvPr/>
        </p:nvSpPr>
        <p:spPr>
          <a:xfrm>
            <a:off x="7562144" y="1710779"/>
            <a:ext cx="2298031" cy="1479883"/>
          </a:xfrm>
          <a:custGeom>
            <a:avLst/>
            <a:gdLst>
              <a:gd name="connsiteX0" fmla="*/ 0 w 2298031"/>
              <a:gd name="connsiteY0" fmla="*/ 1431758 h 1479884"/>
              <a:gd name="connsiteX1" fmla="*/ 757989 w 2298031"/>
              <a:gd name="connsiteY1" fmla="*/ 794084 h 1479884"/>
              <a:gd name="connsiteX2" fmla="*/ 1395663 w 2298031"/>
              <a:gd name="connsiteY2" fmla="*/ 372979 h 1479884"/>
              <a:gd name="connsiteX3" fmla="*/ 2298031 w 2298031"/>
              <a:gd name="connsiteY3" fmla="*/ 0 h 1479884"/>
              <a:gd name="connsiteX4" fmla="*/ 2298031 w 2298031"/>
              <a:gd name="connsiteY4" fmla="*/ 288758 h 1479884"/>
              <a:gd name="connsiteX5" fmla="*/ 2045368 w 2298031"/>
              <a:gd name="connsiteY5" fmla="*/ 385011 h 1479884"/>
              <a:gd name="connsiteX6" fmla="*/ 926431 w 2298031"/>
              <a:gd name="connsiteY6" fmla="*/ 1034716 h 1479884"/>
              <a:gd name="connsiteX7" fmla="*/ 324852 w 2298031"/>
              <a:gd name="connsiteY7" fmla="*/ 1479884 h 1479884"/>
              <a:gd name="connsiteX8" fmla="*/ 0 w 2298031"/>
              <a:gd name="connsiteY8" fmla="*/ 1431758 h 14798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298031" h="1479884">
                <a:moveTo>
                  <a:pt x="0" y="1431758"/>
                </a:moveTo>
                <a:lnTo>
                  <a:pt x="757989" y="794084"/>
                </a:lnTo>
                <a:lnTo>
                  <a:pt x="1395663" y="372979"/>
                </a:lnTo>
                <a:lnTo>
                  <a:pt x="2298031" y="0"/>
                </a:lnTo>
                <a:lnTo>
                  <a:pt x="2298031" y="288758"/>
                </a:lnTo>
                <a:lnTo>
                  <a:pt x="2045368" y="385011"/>
                </a:lnTo>
                <a:lnTo>
                  <a:pt x="926431" y="1034716"/>
                </a:lnTo>
                <a:lnTo>
                  <a:pt x="324852" y="1479884"/>
                </a:lnTo>
                <a:lnTo>
                  <a:pt x="0" y="1431758"/>
                </a:lnTo>
                <a:close/>
              </a:path>
            </a:pathLst>
          </a:cu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n w="38100">
                <a:solidFill>
                  <a:schemeClr val="tx1"/>
                </a:solidFill>
              </a:ln>
              <a:noFill/>
            </a:endParaRPr>
          </a:p>
        </p:txBody>
      </p:sp>
      <p:sp>
        <p:nvSpPr>
          <p:cNvPr id="47" name="Textfeld 46"/>
          <p:cNvSpPr txBox="1"/>
          <p:nvPr/>
        </p:nvSpPr>
        <p:spPr>
          <a:xfrm rot="16200000">
            <a:off x="2010204" y="2047994"/>
            <a:ext cx="65755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Time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3606984" y="3580164"/>
            <a:ext cx="72827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FSC-A</a:t>
            </a:r>
          </a:p>
        </p:txBody>
      </p:sp>
      <p:sp>
        <p:nvSpPr>
          <p:cNvPr id="50" name="Textfeld 49"/>
          <p:cNvSpPr txBox="1"/>
          <p:nvPr/>
        </p:nvSpPr>
        <p:spPr>
          <a:xfrm rot="16200000">
            <a:off x="6578315" y="2047994"/>
            <a:ext cx="73468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FSC-H</a:t>
            </a:r>
          </a:p>
        </p:txBody>
      </p:sp>
      <p:sp>
        <p:nvSpPr>
          <p:cNvPr id="51" name="Textfeld 50"/>
          <p:cNvSpPr txBox="1"/>
          <p:nvPr/>
        </p:nvSpPr>
        <p:spPr>
          <a:xfrm rot="16200000">
            <a:off x="11276758" y="2048004"/>
            <a:ext cx="72827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FSC-A</a:t>
            </a:r>
          </a:p>
        </p:txBody>
      </p:sp>
      <p:sp>
        <p:nvSpPr>
          <p:cNvPr id="52" name="Textfeld 51"/>
          <p:cNvSpPr txBox="1"/>
          <p:nvPr/>
        </p:nvSpPr>
        <p:spPr>
          <a:xfrm rot="16200000">
            <a:off x="10021099" y="5484636"/>
            <a:ext cx="322024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PerCP-Cy5.5 – EMA/CD14/CD19</a:t>
            </a:r>
          </a:p>
        </p:txBody>
      </p:sp>
      <p:sp>
        <p:nvSpPr>
          <p:cNvPr id="53" name="Textfeld 52"/>
          <p:cNvSpPr txBox="1"/>
          <p:nvPr/>
        </p:nvSpPr>
        <p:spPr>
          <a:xfrm rot="16200000">
            <a:off x="6166544" y="5484636"/>
            <a:ext cx="156113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Pe-Cy7 – CD56</a:t>
            </a:r>
          </a:p>
        </p:txBody>
      </p:sp>
      <p:sp>
        <p:nvSpPr>
          <p:cNvPr id="54" name="Textfeld 53"/>
          <p:cNvSpPr txBox="1"/>
          <p:nvPr/>
        </p:nvSpPr>
        <p:spPr>
          <a:xfrm rot="16200000">
            <a:off x="1546384" y="5482815"/>
            <a:ext cx="156113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Pe-Cy7 – CD56</a:t>
            </a:r>
          </a:p>
        </p:txBody>
      </p:sp>
      <p:sp>
        <p:nvSpPr>
          <p:cNvPr id="55" name="Textfeld 54"/>
          <p:cNvSpPr txBox="1"/>
          <p:nvPr/>
        </p:nvSpPr>
        <p:spPr>
          <a:xfrm rot="16200000">
            <a:off x="3839371" y="8582413"/>
            <a:ext cx="156113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Pe-Cy7 – CD56</a:t>
            </a:r>
          </a:p>
        </p:txBody>
      </p:sp>
      <p:sp>
        <p:nvSpPr>
          <p:cNvPr id="56" name="Textfeld 55"/>
          <p:cNvSpPr txBox="1"/>
          <p:nvPr/>
        </p:nvSpPr>
        <p:spPr>
          <a:xfrm rot="16200000">
            <a:off x="8622170" y="8582415"/>
            <a:ext cx="156113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Pe-Cy7 – CD56</a:t>
            </a:r>
          </a:p>
        </p:txBody>
      </p:sp>
      <p:sp>
        <p:nvSpPr>
          <p:cNvPr id="57" name="Textfeld 56"/>
          <p:cNvSpPr txBox="1"/>
          <p:nvPr/>
        </p:nvSpPr>
        <p:spPr>
          <a:xfrm>
            <a:off x="8285503" y="3574740"/>
            <a:ext cx="72827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FSC-A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12979968" y="3578256"/>
            <a:ext cx="72827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FSC-A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12979968" y="7088700"/>
            <a:ext cx="72827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FSC-A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7917521" y="7109525"/>
            <a:ext cx="159370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APC-Cy7 – CD3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3174270" y="7128807"/>
            <a:ext cx="159370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APC-Cy7 – CD3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5572073" y="10159407"/>
            <a:ext cx="14718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V450 – TNF-</a:t>
            </a:r>
            <a:r>
              <a:rPr lang="el-GR" b="1" dirty="0"/>
              <a:t>α</a:t>
            </a:r>
            <a:endParaRPr lang="de-DE" b="1" dirty="0"/>
          </a:p>
        </p:txBody>
      </p:sp>
      <p:sp>
        <p:nvSpPr>
          <p:cNvPr id="64" name="Textfeld 63"/>
          <p:cNvSpPr txBox="1"/>
          <p:nvPr/>
        </p:nvSpPr>
        <p:spPr>
          <a:xfrm>
            <a:off x="10353682" y="10155224"/>
            <a:ext cx="128753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/>
              <a:t>APC – IFN-</a:t>
            </a:r>
            <a:r>
              <a:rPr lang="el-GR" b="1" dirty="0"/>
              <a:t>γ</a:t>
            </a:r>
            <a:endParaRPr lang="de-DE" b="1" dirty="0"/>
          </a:p>
        </p:txBody>
      </p:sp>
      <p:sp>
        <p:nvSpPr>
          <p:cNvPr id="62" name="Textfeld 2"/>
          <p:cNvSpPr txBox="1">
            <a:spLocks noChangeArrowheads="1"/>
          </p:cNvSpPr>
          <p:nvPr/>
        </p:nvSpPr>
        <p:spPr bwMode="auto">
          <a:xfrm>
            <a:off x="2248817" y="10755444"/>
            <a:ext cx="12320968" cy="27828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ts val="1300"/>
              </a:lnSpc>
              <a:spcAft>
                <a:spcPts val="0"/>
              </a:spcAft>
            </a:pPr>
            <a:r>
              <a:rPr lang="en-US" b="1" dirty="0" smtClean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upplementary figure 1.</a:t>
            </a:r>
            <a:r>
              <a:rPr lang="en-US" dirty="0" smtClean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Exemplary gating strategy to analyze the cytokine response of CD56</a:t>
            </a:r>
            <a:r>
              <a:rPr lang="en-US" baseline="30000" dirty="0" smtClean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dirty="0" smtClean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/CD3</a:t>
            </a:r>
            <a:r>
              <a:rPr lang="en-US" baseline="30000" dirty="0" smtClean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dirty="0" smtClean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natural killer cells </a:t>
            </a:r>
            <a:endParaRPr lang="de-DE" dirty="0">
              <a:solidFill>
                <a:srgbClr val="000000"/>
              </a:solidFill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12534128" y="4049009"/>
            <a:ext cx="157222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 err="1" smtClean="0"/>
              <a:t>Exclusion</a:t>
            </a:r>
            <a:r>
              <a:rPr lang="de-DE" b="1" dirty="0" smtClean="0"/>
              <a:t> Gate</a:t>
            </a:r>
            <a:endParaRPr lang="de-DE" b="1" dirty="0"/>
          </a:p>
        </p:txBody>
      </p:sp>
      <p:sp>
        <p:nvSpPr>
          <p:cNvPr id="69" name="Textfeld 68"/>
          <p:cNvSpPr txBox="1"/>
          <p:nvPr/>
        </p:nvSpPr>
        <p:spPr>
          <a:xfrm>
            <a:off x="8190522" y="4049009"/>
            <a:ext cx="9316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 smtClean="0"/>
              <a:t>NK </a:t>
            </a:r>
            <a:r>
              <a:rPr lang="de-DE" b="1" dirty="0" err="1" smtClean="0"/>
              <a:t>cells</a:t>
            </a:r>
            <a:endParaRPr lang="de-DE" b="1" dirty="0"/>
          </a:p>
        </p:txBody>
      </p:sp>
      <p:sp>
        <p:nvSpPr>
          <p:cNvPr id="70" name="Textfeld 69"/>
          <p:cNvSpPr txBox="1"/>
          <p:nvPr/>
        </p:nvSpPr>
        <p:spPr>
          <a:xfrm>
            <a:off x="2879219" y="4044313"/>
            <a:ext cx="21838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 smtClean="0"/>
              <a:t>CD56</a:t>
            </a:r>
            <a:r>
              <a:rPr lang="de-DE" b="1" baseline="30000" dirty="0" smtClean="0"/>
              <a:t>bright/</a:t>
            </a:r>
            <a:r>
              <a:rPr lang="de-DE" b="1" baseline="30000" dirty="0" err="1" smtClean="0"/>
              <a:t>dim</a:t>
            </a:r>
            <a:r>
              <a:rPr lang="de-DE" b="1" dirty="0" smtClean="0"/>
              <a:t> NK </a:t>
            </a:r>
            <a:r>
              <a:rPr lang="de-DE" b="1" dirty="0" err="1" smtClean="0"/>
              <a:t>cells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38843987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feld 2"/>
          <p:cNvSpPr txBox="1">
            <a:spLocks noChangeArrowheads="1"/>
          </p:cNvSpPr>
          <p:nvPr/>
        </p:nvSpPr>
        <p:spPr bwMode="auto">
          <a:xfrm>
            <a:off x="1043269" y="11970328"/>
            <a:ext cx="15809985" cy="1338828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 smtClean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upplementary figure 2.</a:t>
            </a:r>
            <a:r>
              <a:rPr lang="en-US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 Antiviral cytokine response by NK cells after contact with HBV without target cells for 24 hours. (A) shows the MFI values of IFN-γ</a:t>
            </a:r>
            <a:r>
              <a:rPr lang="en-US" baseline="300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 NK cells and (B) the respective frequencies. (C) shows the MFI values of TNF-α</a:t>
            </a:r>
            <a:r>
              <a:rPr lang="en-US" baseline="300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 NK cells and (D) the respective frequencies (n = 3). Appearance: median with interquartile </a:t>
            </a:r>
            <a:r>
              <a:rPr lang="en-US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range. </a:t>
            </a:r>
            <a:r>
              <a:rPr lang="en-US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Statistical analysis: Friedman test with Dunn’s multiple comparisons test. </a:t>
            </a:r>
            <a:endParaRPr lang="de-DE" dirty="0">
              <a:solidFill>
                <a:srgbClr val="000000"/>
              </a:solidFill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269" y="145473"/>
            <a:ext cx="15809985" cy="11824855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546192" y="493485"/>
            <a:ext cx="41710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000" b="1" dirty="0" smtClean="0"/>
              <a:t>A</a:t>
            </a:r>
            <a:endParaRPr lang="de-DE" sz="3000" b="1" dirty="0"/>
          </a:p>
        </p:txBody>
      </p:sp>
      <p:sp>
        <p:nvSpPr>
          <p:cNvPr id="71" name="Textfeld 70"/>
          <p:cNvSpPr txBox="1"/>
          <p:nvPr/>
        </p:nvSpPr>
        <p:spPr>
          <a:xfrm>
            <a:off x="9290621" y="493485"/>
            <a:ext cx="40107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000" b="1" dirty="0" smtClean="0"/>
              <a:t>B</a:t>
            </a:r>
            <a:endParaRPr lang="de-DE" sz="3000" b="1" dirty="0"/>
          </a:p>
        </p:txBody>
      </p:sp>
      <p:sp>
        <p:nvSpPr>
          <p:cNvPr id="72" name="Textfeld 71"/>
          <p:cNvSpPr txBox="1"/>
          <p:nvPr/>
        </p:nvSpPr>
        <p:spPr>
          <a:xfrm>
            <a:off x="1546192" y="5954907"/>
            <a:ext cx="38824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000" b="1" dirty="0" smtClean="0"/>
              <a:t>C</a:t>
            </a:r>
            <a:endParaRPr lang="de-DE" sz="3000" b="1" dirty="0"/>
          </a:p>
        </p:txBody>
      </p:sp>
      <p:sp>
        <p:nvSpPr>
          <p:cNvPr id="73" name="Textfeld 72"/>
          <p:cNvSpPr txBox="1"/>
          <p:nvPr/>
        </p:nvSpPr>
        <p:spPr>
          <a:xfrm>
            <a:off x="9290621" y="5954907"/>
            <a:ext cx="42672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000" b="1" dirty="0" smtClean="0"/>
              <a:t>D</a:t>
            </a:r>
            <a:endParaRPr lang="de-DE" sz="3000" b="1" dirty="0"/>
          </a:p>
        </p:txBody>
      </p:sp>
    </p:spTree>
    <p:extLst>
      <p:ext uri="{BB962C8B-B14F-4D97-AF65-F5344CB8AC3E}">
        <p14:creationId xmlns:p14="http://schemas.microsoft.com/office/powerpoint/2010/main" val="1080019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4</Words>
  <Application>Microsoft Office PowerPoint</Application>
  <PresentationFormat>Benutzerdefiniert</PresentationFormat>
  <Paragraphs>28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Company>Universität Regens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user</dc:creator>
  <cp:lastModifiedBy>Paul Kupke</cp:lastModifiedBy>
  <cp:revision>9</cp:revision>
  <dcterms:created xsi:type="dcterms:W3CDTF">2024-03-05T07:57:55Z</dcterms:created>
  <dcterms:modified xsi:type="dcterms:W3CDTF">2024-04-28T15:29:44Z</dcterms:modified>
</cp:coreProperties>
</file>